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  <p:sldId id="264" r:id="rId3"/>
    <p:sldId id="266" r:id="rId4"/>
    <p:sldId id="26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0" autoAdjust="0"/>
    <p:restoredTop sz="94660"/>
  </p:normalViewPr>
  <p:slideViewPr>
    <p:cSldViewPr snapToGrid="0">
      <p:cViewPr varScale="1">
        <p:scale>
          <a:sx n="61" d="100"/>
          <a:sy n="61" d="100"/>
        </p:scale>
        <p:origin x="109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8C2D8D-FA5C-30FB-9753-4F10EA9092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2B25DEC-EE6D-C5AA-A3A2-7D288148C5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en-US" altLang="ja-JP"/>
              <a:t>Click to edit Master subtitle style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269BF0-C3C6-F75A-1CF7-56DCDC2350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DD133-4281-454B-8B81-4C7E9C43BA0C}" type="datetimeFigureOut">
              <a:rPr kumimoji="1" lang="ja-JP" altLang="en-US" smtClean="0"/>
              <a:t>2025/11/19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7AC6ED-4745-2734-8300-9FE62ACBDB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B5A56E-7CCE-23F5-0C4F-2618FB1E66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4D69D-55AA-4E54-A2F3-00D7D20E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2856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8CC0CA-865C-FF2D-C709-7229FE8695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51B4E34-40BF-9478-D0BC-CCB0C6F67F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19EE6A-37CE-FCF8-9323-5080F55ED5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DD133-4281-454B-8B81-4C7E9C43BA0C}" type="datetimeFigureOut">
              <a:rPr kumimoji="1" lang="ja-JP" altLang="en-US" smtClean="0"/>
              <a:t>2025/11/19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5B0602-6737-3ECC-9B91-11D77FAB23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54EA63-0EDE-DE12-AB28-2FDAE97AD6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4D69D-55AA-4E54-A2F3-00D7D20E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43679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C453E83-18B0-DB3E-2619-B41272ABFC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037382-F5D2-F6BA-62FD-134480D867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4E8BBA-54DC-A90F-96B5-0BC0DFC0EF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DD133-4281-454B-8B81-4C7E9C43BA0C}" type="datetimeFigureOut">
              <a:rPr kumimoji="1" lang="ja-JP" altLang="en-US" smtClean="0"/>
              <a:t>2025/11/19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974648-BE9A-475E-7F70-A6234973F6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C68D90-6BB5-A861-B1CD-E359E89225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4D69D-55AA-4E54-A2F3-00D7D20E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19035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6E557D-B314-8CCB-19F6-0B16973C15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D60A87-0C4C-A110-CC51-94301A95CC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CC82A9-DE72-60A1-7999-9796FEA996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DD133-4281-454B-8B81-4C7E9C43BA0C}" type="datetimeFigureOut">
              <a:rPr kumimoji="1" lang="ja-JP" altLang="en-US" smtClean="0"/>
              <a:t>2025/11/19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0040F7-F327-87A7-AFE2-8D2056500C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07B5A3-4F10-674E-F686-DD604391AA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4D69D-55AA-4E54-A2F3-00D7D20E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33696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508310-CD5C-9FD1-601A-74AE7D91AC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9D6C95-07E2-F089-9847-41A20AD4AA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53580F-0023-5A8C-A367-C39C36134D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DD133-4281-454B-8B81-4C7E9C43BA0C}" type="datetimeFigureOut">
              <a:rPr kumimoji="1" lang="ja-JP" altLang="en-US" smtClean="0"/>
              <a:t>2025/11/19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1699B4-66BE-E195-DEF1-79C00C1078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D49CEB-1B6A-8A93-0B58-700FABC061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4D69D-55AA-4E54-A2F3-00D7D20E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57677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8B3F7B-B53C-B416-E753-CF46688ECD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2A2D71-0501-E04D-1C73-B37D6A1F441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7CB212-9EE4-A510-16E2-A86A8F7608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0E73DA-1014-58A1-5DC4-6F1C7A937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DD133-4281-454B-8B81-4C7E9C43BA0C}" type="datetimeFigureOut">
              <a:rPr kumimoji="1" lang="ja-JP" altLang="en-US" smtClean="0"/>
              <a:t>2025/11/19</a:t>
            </a:fld>
            <a:endParaRPr kumimoji="1" lang="ja-JP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253051-32D3-6F66-D0A8-A01443CF1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0E1303-C38D-EC84-E7B5-D7940C3DE8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4D69D-55AA-4E54-A2F3-00D7D20E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67569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D8B014-2630-2010-EF73-177271C0CA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BFA32C-AE9A-7924-DB05-9F90A30B10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9C6512-987C-8B72-DD88-EE8B53881F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F0C851B-68FE-D7AF-6873-725719BFC69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F209823-B773-7758-44BD-7743756908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31FF79A-97DB-FFAB-A71C-6AB07FD74B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DD133-4281-454B-8B81-4C7E9C43BA0C}" type="datetimeFigureOut">
              <a:rPr kumimoji="1" lang="ja-JP" altLang="en-US" smtClean="0"/>
              <a:t>2025/11/19</a:t>
            </a:fld>
            <a:endParaRPr kumimoji="1" lang="ja-JP" alt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9AA409D-C268-AFA0-3420-5E606FAA72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AE094F8-C9D1-A8D9-69C2-37008A3D8C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4D69D-55AA-4E54-A2F3-00D7D20E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7146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DAF070-44D3-59A8-31EF-52A8F3EE10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AFFE930-9087-8860-A982-03CE0F0B5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DD133-4281-454B-8B81-4C7E9C43BA0C}" type="datetimeFigureOut">
              <a:rPr kumimoji="1" lang="ja-JP" altLang="en-US" smtClean="0"/>
              <a:t>2025/11/19</a:t>
            </a:fld>
            <a:endParaRPr kumimoji="1" lang="ja-JP" alt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C287E70-A0E5-5EA9-D0BA-D326ECD14C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5D8D8F7-2DB6-C603-424A-E660978C7F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4D69D-55AA-4E54-A2F3-00D7D20E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02485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064912F-7179-2341-9F05-9CC9AA67BD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DD133-4281-454B-8B81-4C7E9C43BA0C}" type="datetimeFigureOut">
              <a:rPr kumimoji="1" lang="ja-JP" altLang="en-US" smtClean="0"/>
              <a:t>2025/11/19</a:t>
            </a:fld>
            <a:endParaRPr kumimoji="1" lang="ja-JP" alt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E847C0F-E36E-569B-08CC-9D83C8C86B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34B582A-929A-AE69-7A22-705341F3D6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4D69D-55AA-4E54-A2F3-00D7D20E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29734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E7E164-77C6-A1B3-99B3-2420977B8A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8DAB6A-3EF2-9315-A6F9-44096C0C44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5D23AFC-6CFF-3787-83D0-AC35C7B12F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77D658-BB40-8BBD-1785-C3B912071F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DD133-4281-454B-8B81-4C7E9C43BA0C}" type="datetimeFigureOut">
              <a:rPr kumimoji="1" lang="ja-JP" altLang="en-US" smtClean="0"/>
              <a:t>2025/11/19</a:t>
            </a:fld>
            <a:endParaRPr kumimoji="1" lang="ja-JP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2A291F-A35D-EB57-00AF-42FA7A0EE1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70A5BC-F0C0-E496-9976-874D73E8D9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4D69D-55AA-4E54-A2F3-00D7D20E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80831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8E47CD-F4F8-B5F7-A63D-901C91035E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690ABD5-B679-7C45-81A6-C64DBAA77E3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3786D7-1EC5-0171-56D5-A44340F46D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en-US" altLang="ja-JP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E178C5-0797-8433-96E6-A401B09529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DDD133-4281-454B-8B81-4C7E9C43BA0C}" type="datetimeFigureOut">
              <a:rPr kumimoji="1" lang="ja-JP" altLang="en-US" smtClean="0"/>
              <a:t>2025/11/19</a:t>
            </a:fld>
            <a:endParaRPr kumimoji="1" lang="ja-JP" alt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3CBD79-540B-95CB-23E0-728D482924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A77E57-39F0-E720-D183-8B5D32709A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4D69D-55AA-4E54-A2F3-00D7D20E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68417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6543D6C-6A76-D2DB-06BA-AFD98F071F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en-US" altLang="ja-JP"/>
              <a:t>Click to edit Master title style</a:t>
            </a:r>
            <a:endParaRPr kumimoji="1" lang="ja-JP" alt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66D9E5-492B-645C-FA3A-42C2CBA2BC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F8479D-5E44-ECC9-EECD-8CDD0B80161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CDDD133-4281-454B-8B81-4C7E9C43BA0C}" type="datetimeFigureOut">
              <a:rPr kumimoji="1" lang="ja-JP" altLang="en-US" smtClean="0"/>
              <a:t>2025/11/19</a:t>
            </a:fld>
            <a:endParaRPr kumimoji="1"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F3B499-EAB4-688A-2D8B-D40624391A0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CC9B4C-5C98-9224-B66F-93884CD45A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114D69D-55AA-4E54-A2F3-00D7D20E221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16309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042065A-0F3F-A528-3123-852E089900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6277" y="623455"/>
            <a:ext cx="9059441" cy="429195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7390019-9D63-6BF1-2DFD-97F323688FFE}"/>
              </a:ext>
            </a:extLst>
          </p:cNvPr>
          <p:cNvSpPr txBox="1"/>
          <p:nvPr/>
        </p:nvSpPr>
        <p:spPr>
          <a:xfrm>
            <a:off x="170772" y="5232854"/>
            <a:ext cx="11850449" cy="64633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 anchor="ctr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. 1.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etection of the </a:t>
            </a:r>
            <a:r>
              <a:rPr kumimoji="0" lang="en-US" sz="18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laB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ene specific for </a:t>
            </a:r>
            <a:r>
              <a:rPr kumimoji="0" lang="en-GB" altLang="ja-JP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orrelia theileri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M: marker, N: negative control, and the numbers of positive samples for sheep from numbers 1 to7</a:t>
            </a:r>
          </a:p>
        </p:txBody>
      </p:sp>
    </p:spTree>
    <p:extLst>
      <p:ext uri="{BB962C8B-B14F-4D97-AF65-F5344CB8AC3E}">
        <p14:creationId xmlns:p14="http://schemas.microsoft.com/office/powerpoint/2010/main" val="30945770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B5381C8-36FB-3614-88EC-757EB602C8E7}"/>
              </a:ext>
            </a:extLst>
          </p:cNvPr>
          <p:cNvSpPr txBox="1"/>
          <p:nvPr/>
        </p:nvSpPr>
        <p:spPr>
          <a:xfrm>
            <a:off x="170775" y="5676515"/>
            <a:ext cx="11850449" cy="64633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 anchor="ctr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. 2.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etection of the </a:t>
            </a:r>
            <a:r>
              <a:rPr kumimoji="0" lang="en-US" sz="18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laB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ene specific for </a:t>
            </a:r>
            <a:r>
              <a:rPr kumimoji="0" lang="en-GB" altLang="ja-JP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orrelia theileri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M: marker, N: negative control, and the numbers of positive samples for goats are  2, 5 and 8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EE675CF-C493-6F36-10D6-145F4A0635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76489" y="203885"/>
            <a:ext cx="5377138" cy="53588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19383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9B91E89-7107-8A7B-618C-8D0FB8E6D9BC}"/>
              </a:ext>
            </a:extLst>
          </p:cNvPr>
          <p:cNvSpPr txBox="1"/>
          <p:nvPr/>
        </p:nvSpPr>
        <p:spPr>
          <a:xfrm>
            <a:off x="238804" y="5643779"/>
            <a:ext cx="11478418" cy="64633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 anchor="ctr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. 3.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: Detection of the </a:t>
            </a:r>
            <a:r>
              <a:rPr kumimoji="0" lang="en-US" sz="18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ltA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gene specific for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Rickettsia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aeschlimannii (M: marker, N: negative control, and the numbers of positive in samples from 1 to 6 for sheep and from 7 to 10 for goat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4EB48C5-6AB4-C6B9-1044-02B606FF68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35797" y="567890"/>
            <a:ext cx="9120406" cy="48406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79576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DDEF062-5E7C-7464-2C6E-0463F105C839}"/>
              </a:ext>
            </a:extLst>
          </p:cNvPr>
          <p:cNvSpPr txBox="1"/>
          <p:nvPr/>
        </p:nvSpPr>
        <p:spPr>
          <a:xfrm>
            <a:off x="747559" y="5318809"/>
            <a:ext cx="11164529" cy="92333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 anchor="ctr">
            <a:spAutoFit/>
          </a:bodyPr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Supplementary Fig. 4.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Detection of the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16S rRNA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gene specific for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ycoplasma </a:t>
            </a:r>
            <a:r>
              <a:rPr kumimoji="0" lang="en-US" sz="18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vis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and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ycoplasma </a:t>
            </a:r>
            <a:r>
              <a:rPr kumimoji="0" lang="en-US" sz="18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wenyonii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</a:p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(M: marker, N: negative control), and the numbers of positive samples of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ycoplasma </a:t>
            </a:r>
            <a:r>
              <a:rPr kumimoji="0" lang="en-US" sz="18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vis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in sheep from number 1 to 4 and in from 5 to 7 goat, and the numbers of positive samples of </a:t>
            </a:r>
            <a:r>
              <a:rPr kumimoji="0" lang="en-US" sz="18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Mycoplasma </a:t>
            </a:r>
            <a:r>
              <a:rPr kumimoji="0" lang="en-US" sz="1800" b="0" i="1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wenyonii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  in sheep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from number 8 to 12 </a:t>
            </a:r>
            <a:endParaRPr kumimoji="0" 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+mn-ea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A87B641-CEA5-0A6E-12CB-8AF306F9BC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9167" y="821724"/>
            <a:ext cx="11473666" cy="42370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7414258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1</TotalTime>
  <Words>187</Words>
  <Application>Microsoft Office PowerPoint</Application>
  <PresentationFormat>Widescreen</PresentationFormat>
  <Paragraphs>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游ゴシック</vt:lpstr>
      <vt:lpstr>游ゴシック Light</vt:lpstr>
      <vt:lpstr>Arial</vt:lpstr>
      <vt:lpstr>Times New Roman</vt:lpstr>
      <vt:lpstr>1_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ssan youssef</dc:creator>
  <cp:lastModifiedBy>hassan youssef</cp:lastModifiedBy>
  <cp:revision>11</cp:revision>
  <dcterms:created xsi:type="dcterms:W3CDTF">2025-06-20T12:29:39Z</dcterms:created>
  <dcterms:modified xsi:type="dcterms:W3CDTF">2025-11-19T07:11:17Z</dcterms:modified>
</cp:coreProperties>
</file>